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tags" Target="../tags/tag64.xml"/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JEV 探针浓度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3060700" y="321310"/>
            <a:ext cx="5480685" cy="3260090"/>
          </a:xfrm>
          <a:prstGeom prst="rect">
            <a:avLst/>
          </a:prstGeom>
        </p:spPr>
      </p:pic>
      <p:pic>
        <p:nvPicPr>
          <p:cNvPr id="6" name="图片 5" descr="GETV 探针浓度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61335" y="3491230"/>
            <a:ext cx="5480050" cy="325945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709545" y="450850"/>
            <a:ext cx="3517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709545" y="3581400"/>
            <a:ext cx="3517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右大括号 8"/>
          <p:cNvSpPr/>
          <p:nvPr/>
        </p:nvSpPr>
        <p:spPr>
          <a:xfrm>
            <a:off x="8437880" y="676910"/>
            <a:ext cx="158115" cy="213995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8655685" y="600075"/>
            <a:ext cx="13449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GETV-Probe  0.5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 JEV - Probe   0.3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右大括号 11"/>
          <p:cNvSpPr/>
          <p:nvPr/>
        </p:nvSpPr>
        <p:spPr>
          <a:xfrm>
            <a:off x="8423910" y="1025525"/>
            <a:ext cx="158115" cy="234315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8655685" y="960120"/>
            <a:ext cx="233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GETV-Probe  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0.3ul/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0.4ul/0.4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 JEV - Probe   0.3ul/0.3ul/0.4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ul</a:t>
            </a:r>
            <a:endParaRPr lang="zh-CN" altLang="en-US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8655685" y="1273810"/>
            <a:ext cx="24745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GETV-Probe  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0.3ul/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0.5ul/0.5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 JEV - Probe   0.4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ul/0.4ul/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0.5ul</a:t>
            </a:r>
            <a:endParaRPr lang="zh-CN" altLang="en-US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6" name="右大括号 15"/>
          <p:cNvSpPr/>
          <p:nvPr/>
        </p:nvSpPr>
        <p:spPr>
          <a:xfrm>
            <a:off x="8416290" y="1328420"/>
            <a:ext cx="186690" cy="165735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8655685" y="1593215"/>
            <a:ext cx="1593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GETV-Probe  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0.3ul/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0.4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 JEV - Probe   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0.5ul</a:t>
            </a:r>
            <a:endParaRPr lang="zh-CN" altLang="en-US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右大括号 17"/>
          <p:cNvSpPr/>
          <p:nvPr/>
        </p:nvSpPr>
        <p:spPr>
          <a:xfrm>
            <a:off x="8415655" y="1593850"/>
            <a:ext cx="194945" cy="213995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9" name="右大括号 18"/>
          <p:cNvSpPr/>
          <p:nvPr/>
        </p:nvSpPr>
        <p:spPr>
          <a:xfrm>
            <a:off x="8409305" y="3839845"/>
            <a:ext cx="186690" cy="165735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8572500" y="3738880"/>
            <a:ext cx="13449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GETV-Probe  0.5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 JEV - Probe   0.3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" name="右大括号 20"/>
          <p:cNvSpPr/>
          <p:nvPr/>
        </p:nvSpPr>
        <p:spPr>
          <a:xfrm>
            <a:off x="8400415" y="4107180"/>
            <a:ext cx="172085" cy="187325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" name="右大括号 21"/>
          <p:cNvSpPr/>
          <p:nvPr/>
        </p:nvSpPr>
        <p:spPr>
          <a:xfrm>
            <a:off x="8419465" y="4478020"/>
            <a:ext cx="194945" cy="213995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8582025" y="4057650"/>
            <a:ext cx="25292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GETV-Probe  0.3ul/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0.4ul/0.4ul/0.5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 JEV - Probe   0.3ul/0.3ul/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0.4ul/0.4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8582025" y="4400550"/>
            <a:ext cx="24263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GETV-Probe  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0.3ul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/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0.4ul/0.5ul</a:t>
            </a:r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/0.3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 JEV - Probe   0.5ul/0.5ul/0.5ul/0.4u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039995" y="2299335"/>
            <a:ext cx="6896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charset="0"/>
                <a:cs typeface="Times New Roman" panose="02020603050405020304" charset="0"/>
              </a:rPr>
              <a:t>JEV</a:t>
            </a:r>
            <a:endParaRPr lang="en-US" altLang="zh-CN" b="1">
              <a:solidFill>
                <a:schemeClr val="tx2">
                  <a:lumMod val="75000"/>
                  <a:lumOff val="2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377690" y="5398770"/>
            <a:ext cx="890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solidFill>
                  <a:schemeClr val="accent3">
                    <a:lumMod val="50000"/>
                  </a:schemeClr>
                </a:solidFill>
                <a:latin typeface="Times New Roman" panose="02020603050405020304" charset="0"/>
                <a:cs typeface="Times New Roman" panose="02020603050405020304" charset="0"/>
              </a:rPr>
              <a:t>GETV</a:t>
            </a:r>
            <a:endParaRPr lang="en-US" altLang="zh-CN" b="1">
              <a:solidFill>
                <a:schemeClr val="accent3">
                  <a:lumMod val="50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4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PLACING_PICTURE_USER_VIEWPORT" val="{&quot;height&quot;:4299,&quot;width&quot;:7227}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4</Words>
  <Application>WPS 演示</Application>
  <PresentationFormat>宽屏</PresentationFormat>
  <Paragraphs>29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洋流飘。</cp:lastModifiedBy>
  <cp:revision>151</cp:revision>
  <dcterms:created xsi:type="dcterms:W3CDTF">2019-06-19T02:08:00Z</dcterms:created>
  <dcterms:modified xsi:type="dcterms:W3CDTF">2022-03-16T06:51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365</vt:lpwstr>
  </property>
  <property fmtid="{D5CDD505-2E9C-101B-9397-08002B2CF9AE}" pid="3" name="ICV">
    <vt:lpwstr>6CA5BF04F2A149CFA04D23A0A00339E0</vt:lpwstr>
  </property>
</Properties>
</file>